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59" d="100"/>
          <a:sy n="59" d="100"/>
        </p:scale>
        <p:origin x="1500" y="5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30/01/202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0/01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0/01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0/01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0/01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0/01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0/01/2025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0/01/2025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0/01/2025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0/01/2025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0/01/2025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0/01/2025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30/01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5496" y="5301208"/>
            <a:ext cx="7344816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owall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Rathmann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(2025) Diabetologia DOI 10.1007/s00125-025-06360-3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5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/>
              <a:t>Marriage, risk of diabetes and benefits of couple-based intervention</a:t>
            </a:r>
            <a:endParaRPr lang="en-GB" sz="1800" b="1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949B614E-10B8-D8BA-5DD5-76EB28BE5A3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15516" y="1683828"/>
            <a:ext cx="8712968" cy="31853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1</Words>
  <Application>Microsoft Office PowerPoint</Application>
  <PresentationFormat>On-screen Show (4:3)</PresentationFormat>
  <Paragraphs>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Deborah Bennett</cp:lastModifiedBy>
  <cp:revision>48</cp:revision>
  <dcterms:created xsi:type="dcterms:W3CDTF">2016-06-15T12:53:43Z</dcterms:created>
  <dcterms:modified xsi:type="dcterms:W3CDTF">2025-01-30T09:56:25Z</dcterms:modified>
</cp:coreProperties>
</file>